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7"/>
  </p:notesMasterIdLst>
  <p:sldIdLst>
    <p:sldId id="257" r:id="rId5"/>
    <p:sldId id="258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12"/>
    <p:restoredTop sz="94726"/>
  </p:normalViewPr>
  <p:slideViewPr>
    <p:cSldViewPr>
      <p:cViewPr varScale="1">
        <p:scale>
          <a:sx n="116" d="100"/>
          <a:sy n="116" d="100"/>
        </p:scale>
        <p:origin x="8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EF17A9-EFC9-CB45-A110-7EF4E80A2BD0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A254FA-EFC9-6B4B-86D2-4C10ED84A4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185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364B9E-7C92-F745-B122-B984E67811D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3187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52F723-8493-9A08-5516-1F5D76B6C0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2689AAA-891F-4938-B122-C28C83C291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9D962A-B992-9D0F-2A23-53ED44517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49CF99-941E-14DF-2E96-074591A3D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B1F0E1-768D-7F81-152D-7CBD6C563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363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53B5E5-B32E-FFAE-18AB-538B8786C5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105642E-CAD8-80AE-3EDC-D4771DA1D3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988B165-FE87-9C5F-377A-8F750E3B3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1D259A-A519-C901-4EA2-B4FE663D2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2BFAE6-A429-3216-527F-9AE4521B8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235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D332248-C623-E8F2-1CEB-73A6A0F9CE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E94D5A6-CD59-D2B1-D431-652CED452D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31F4F6-24E6-0218-F31C-72D98DCF6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C4FB56-CE2F-2BE4-5661-C1990FD15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541B4F-2D11-1680-3FBC-F4B35E631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597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56B039-2DA3-ACE5-881C-D6E978210F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B4D0678-6422-D71A-4829-DBE4A831BE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6AFA2D-9669-E923-E595-9DE23C7E2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1E3F3A4-3AEC-25BA-1E7C-F3F61C3CA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569AD3-A4F4-C4F9-93C2-A32D15828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145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321A83-3AB5-3DDD-2492-9D3BF8F3C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3F509F-590E-1D13-9F07-E57B79E244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96F57C5-9850-8F26-E991-366AB3A97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EE489AA-698D-4378-8AA5-482DDE80AD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0101A7F-1276-64EF-032C-0B5747872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8640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79AD24-5B3E-36C9-0611-FB47533A56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6416A95-8847-4F3C-18B4-ABB348315F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ACF6E32-4C6A-0023-7830-3435CDD177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1153CBB-DF0D-B82B-7936-FD716A14D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2F17322-3D93-8F44-E828-F284C5030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06742D-B54F-041E-0003-B9E782615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907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20D44B-9448-D57D-0859-681F2A715E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50AEFC0-F272-23F6-8BFF-9808AEB8C7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654641-A8C3-3E46-5612-8D1DAEA931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E13E83C-8A29-4F9B-2127-A1C8FE5419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D551E60-599D-2563-0DAD-1C9AA42222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E3F93A7-A7F1-C65B-60CE-67818593F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AA9DA34-2620-7C16-71F8-8F3555B1B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AA8812E-B2F3-D015-871C-4EB37DBC9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3698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66518B-BCFA-6448-02BE-79BDE890F0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89AF5AF-207A-6453-ACAF-84B76B119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65E6373-3F7B-2DB8-0974-422622791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848BF36-D961-6971-09CB-52FB04C4C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912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24CE580-C3C2-6517-FAA8-596CFFDE3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BE75A33-ABD3-DB9D-6929-0D71B440D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48A8670-22A4-3D1D-ED85-829502BA9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6715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A30F91-9A78-EBE9-AB1E-7969AAC76F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6C7ADB3-5F7D-33AE-A13C-B96485692C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66DE316-485E-72C9-FD48-359B06BB1C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A5DFCB9-C138-4A9F-18B4-51E913B56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200FFC0-EC36-45E9-D2E2-43DACAB17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48A2FAF-E0ED-E816-50DD-98A5B08E4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6601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EF3919-2CA3-1F51-924A-D3B004C871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EB5A33A-328B-02A2-B61A-408F60B0A1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CB27976-22AB-A20E-2CB4-78F4458A13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6B341DF-A7F7-E302-F8D4-CC534FD1D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CABA11E-6407-B6E0-FF9C-4E58BDF70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44ACC26-49AD-BB2C-93E9-83737B654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9449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344B8C8-1F9A-385F-7892-9BD062C06A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7037CD4-A128-240E-2451-AAF6ABE5D3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DFBA60-E9C3-565B-E85B-351AC71992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8E1EF1-1DA8-4848-8361-59A2D02C03E1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D0FB23-6327-0F65-3738-2CF27FFA16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62A05C-5714-F744-1733-6AC72065D5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7EC62F-40C1-594F-A18E-7CBB4BE9B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144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86436A16-FAFF-D58B-1964-4A1371D6B9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5058739"/>
              </p:ext>
            </p:extLst>
          </p:nvPr>
        </p:nvGraphicFramePr>
        <p:xfrm>
          <a:off x="296333" y="1093884"/>
          <a:ext cx="5690789" cy="4351340"/>
        </p:xfrm>
        <a:graphic>
          <a:graphicData uri="http://schemas.openxmlformats.org/drawingml/2006/table">
            <a:tbl>
              <a:tblPr/>
              <a:tblGrid>
                <a:gridCol w="437753">
                  <a:extLst>
                    <a:ext uri="{9D8B030D-6E8A-4147-A177-3AD203B41FA5}">
                      <a16:colId xmlns:a16="http://schemas.microsoft.com/office/drawing/2014/main" val="102707481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2800226141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2456553316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2590816743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2376763904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24193912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3578799176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1782112673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2159966588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701349988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992590986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1328159139"/>
                    </a:ext>
                  </a:extLst>
                </a:gridCol>
                <a:gridCol w="437753">
                  <a:extLst>
                    <a:ext uri="{9D8B030D-6E8A-4147-A177-3AD203B41FA5}">
                      <a16:colId xmlns:a16="http://schemas.microsoft.com/office/drawing/2014/main" val="3797559265"/>
                    </a:ext>
                  </a:extLst>
                </a:gridCol>
              </a:tblGrid>
              <a:tr h="245244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2359561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A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4715412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B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3281985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C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8791752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D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4438790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E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0205898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7640720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G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6610346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H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0481973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1EBA58DC-4DD6-EDEA-0959-90E2E991B6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3661469"/>
              </p:ext>
            </p:extLst>
          </p:nvPr>
        </p:nvGraphicFramePr>
        <p:xfrm>
          <a:off x="6096003" y="1093884"/>
          <a:ext cx="5799664" cy="4351340"/>
        </p:xfrm>
        <a:graphic>
          <a:graphicData uri="http://schemas.openxmlformats.org/drawingml/2006/table">
            <a:tbl>
              <a:tblPr/>
              <a:tblGrid>
                <a:gridCol w="446128">
                  <a:extLst>
                    <a:ext uri="{9D8B030D-6E8A-4147-A177-3AD203B41FA5}">
                      <a16:colId xmlns:a16="http://schemas.microsoft.com/office/drawing/2014/main" val="3280183710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421319721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539746871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396949960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1661051223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91517131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1318114875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4234939877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702077505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4086105398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1025768658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3951832150"/>
                    </a:ext>
                  </a:extLst>
                </a:gridCol>
                <a:gridCol w="446128">
                  <a:extLst>
                    <a:ext uri="{9D8B030D-6E8A-4147-A177-3AD203B41FA5}">
                      <a16:colId xmlns:a16="http://schemas.microsoft.com/office/drawing/2014/main" val="3801266392"/>
                    </a:ext>
                  </a:extLst>
                </a:gridCol>
              </a:tblGrid>
              <a:tr h="245244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0967746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A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3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7167559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B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5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6788422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C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7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9629956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D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9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8992581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E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1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7015661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3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3833018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G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5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1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2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0147495"/>
                  </a:ext>
                </a:extLst>
              </a:tr>
              <a:tr h="513262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H</a:t>
                      </a:r>
                    </a:p>
                  </a:txBody>
                  <a:tcPr marL="8759" marR="8759" marT="875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7</a:t>
                      </a:r>
                    </a:p>
                  </a:txBody>
                  <a:tcPr marL="8759" marR="8759" marT="875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7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8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3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4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9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0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8759" marR="8759" marT="875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0112534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922489A-9C0F-5217-9402-618D734EBD24}"/>
              </a:ext>
            </a:extLst>
          </p:cNvPr>
          <p:cNvSpPr txBox="1"/>
          <p:nvPr/>
        </p:nvSpPr>
        <p:spPr>
          <a:xfrm>
            <a:off x="4223792" y="476672"/>
            <a:ext cx="39453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96 well preparation plates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92405CF-8427-216B-D836-5FCD2B79F38B}"/>
              </a:ext>
            </a:extLst>
          </p:cNvPr>
          <p:cNvSpPr txBox="1"/>
          <p:nvPr/>
        </p:nvSpPr>
        <p:spPr>
          <a:xfrm>
            <a:off x="191344" y="116632"/>
            <a:ext cx="5544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le 5</a:t>
            </a:r>
            <a:r>
              <a:rPr lang="ja-JP" altLang="en-US"/>
              <a:t>：</a:t>
            </a:r>
            <a:r>
              <a:rPr lang="en-US" dirty="0"/>
              <a:t>Plate layout templates </a:t>
            </a:r>
            <a:endParaRPr lang="en-JP" dirty="0"/>
          </a:p>
        </p:txBody>
      </p:sp>
    </p:spTree>
    <p:extLst>
      <p:ext uri="{BB962C8B-B14F-4D97-AF65-F5344CB8AC3E}">
        <p14:creationId xmlns:p14="http://schemas.microsoft.com/office/powerpoint/2010/main" val="12952853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61B2B4C0-4248-8E3B-40BD-7812EF5B68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4869925"/>
              </p:ext>
            </p:extLst>
          </p:nvPr>
        </p:nvGraphicFramePr>
        <p:xfrm>
          <a:off x="2184384" y="510986"/>
          <a:ext cx="9000000" cy="6175478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152966455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91665494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72585318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05089014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97215163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8618756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8276910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22093488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43162178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1479631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28776288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20107734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23077398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9466324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18963280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44090481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1406077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97505500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3941496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96596303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27021282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29169429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61376482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35034593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996171518"/>
                    </a:ext>
                  </a:extLst>
                </a:gridCol>
              </a:tblGrid>
              <a:tr h="159519">
                <a:tc>
                  <a:txBody>
                    <a:bodyPr/>
                    <a:lstStyle/>
                    <a:p>
                      <a:pPr algn="l" fontAlgn="ctr"/>
                      <a:endParaRPr lang="ja-JP" alt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12"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d-ROMs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12"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BAP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4414720"/>
                  </a:ext>
                </a:extLst>
              </a:tr>
              <a:tr h="159519"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5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6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7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8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9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0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1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2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3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4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39243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A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6251246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B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5641996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C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707261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D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1620177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E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6160869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6613072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G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5359584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H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9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4368120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I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4995742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J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6551085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K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1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4243720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L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5350872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M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0883472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N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1110698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O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5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1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7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3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9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9129067"/>
                  </a:ext>
                </a:extLst>
              </a:tr>
              <a:tr h="362560"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P</a:t>
                      </a:r>
                    </a:p>
                  </a:txBody>
                  <a:tcPr marL="4379" marR="4379" marT="437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3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72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8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08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24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kn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</a:endParaRP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40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D</a:t>
                      </a:r>
                    </a:p>
                    <a:p>
                      <a:pPr algn="ctr" fontAlgn="ctr"/>
                      <a:r>
                        <a:rPr lang="en" sz="105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</a:t>
                      </a:r>
                    </a:p>
                  </a:txBody>
                  <a:tcPr marL="4379" marR="4379" marT="43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8440152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D2B9B30-904C-7BFD-933C-84902DEDA939}"/>
              </a:ext>
            </a:extLst>
          </p:cNvPr>
          <p:cNvSpPr txBox="1"/>
          <p:nvPr/>
        </p:nvSpPr>
        <p:spPr>
          <a:xfrm>
            <a:off x="5534222" y="11017"/>
            <a:ext cx="31277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384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well assay plate</a:t>
            </a:r>
            <a:endParaRPr kumimoji="1" lang="ja-JP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D1D3BAB-B528-8FBB-4B3B-CBBCCA9064A9}"/>
              </a:ext>
            </a:extLst>
          </p:cNvPr>
          <p:cNvSpPr txBox="1"/>
          <p:nvPr/>
        </p:nvSpPr>
        <p:spPr>
          <a:xfrm>
            <a:off x="0" y="230832"/>
            <a:ext cx="27116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le 5</a:t>
            </a:r>
            <a:r>
              <a:rPr lang="ja-JP" altLang="en-US"/>
              <a:t>：</a:t>
            </a:r>
            <a:endParaRPr lang="en-US" altLang="ja-JP" dirty="0"/>
          </a:p>
          <a:p>
            <a:r>
              <a:rPr lang="en-US" dirty="0"/>
              <a:t>Plate layout templates </a:t>
            </a:r>
            <a:endParaRPr lang="en-JP" dirty="0"/>
          </a:p>
        </p:txBody>
      </p:sp>
    </p:spTree>
    <p:extLst>
      <p:ext uri="{BB962C8B-B14F-4D97-AF65-F5344CB8AC3E}">
        <p14:creationId xmlns:p14="http://schemas.microsoft.com/office/powerpoint/2010/main" val="1008407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7bb26fcd-ba72-4bbf-b389-e35a8816dc95" xsi:nil="true"/>
    <lcf76f155ced4ddcb4097134ff3c332f xmlns="9644bfcf-8bdd-41a6-97ac-521b5ea37eb3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4C8AC90AE570E847BE20D517469CBEDD" ma:contentTypeVersion="14" ma:contentTypeDescription="新しいドキュメントを作成します。" ma:contentTypeScope="" ma:versionID="8283da52106b97f62210a4c6c0d6b887">
  <xsd:schema xmlns:xsd="http://www.w3.org/2001/XMLSchema" xmlns:xs="http://www.w3.org/2001/XMLSchema" xmlns:p="http://schemas.microsoft.com/office/2006/metadata/properties" xmlns:ns2="7bb26fcd-ba72-4bbf-b389-e35a8816dc95" xmlns:ns3="9644bfcf-8bdd-41a6-97ac-521b5ea37eb3" targetNamespace="http://schemas.microsoft.com/office/2006/metadata/properties" ma:root="true" ma:fieldsID="a4282b4e3ffd1feb4e94e6a90c3c8f6e" ns2:_="" ns3:_="">
    <xsd:import namespace="7bb26fcd-ba72-4bbf-b389-e35a8816dc95"/>
    <xsd:import namespace="9644bfcf-8bdd-41a6-97ac-521b5ea37eb3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LengthInSeconds" minOccurs="0"/>
                <xsd:element ref="ns3:MediaServiceObjectDetectorVersions" minOccurs="0"/>
                <xsd:element ref="ns3:MediaServiceGenerationTime" minOccurs="0"/>
                <xsd:element ref="ns3:MediaServiceEventHashCode" minOccurs="0"/>
                <xsd:element ref="ns3:lcf76f155ced4ddcb4097134ff3c332f" minOccurs="0"/>
                <xsd:element ref="ns2:TaxCatchAll" minOccurs="0"/>
                <xsd:element ref="ns3:MediaServiceOCR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bb26fcd-ba72-4bbf-b389-e35a8816dc95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TaxCatchAll" ma:index="19" nillable="true" ma:displayName="Taxonomy Catch All Column" ma:hidden="true" ma:list="{e725de3e-c6cf-4200-8433-9b4fca4c0219}" ma:internalName="TaxCatchAll" ma:showField="CatchAllData" ma:web="7bb26fcd-ba72-4bbf-b389-e35a8816dc9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644bfcf-8bdd-41a6-97ac-521b5ea37eb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8" nillable="true" ma:taxonomy="true" ma:internalName="lcf76f155ced4ddcb4097134ff3c332f" ma:taxonomyFieldName="MediaServiceImageTags" ma:displayName="画像タグ" ma:readOnly="false" ma:fieldId="{5cf76f15-5ced-4ddc-b409-7134ff3c332f}" ma:taxonomyMulti="true" ma:sspId="60da577d-8c11-42e1-9807-59d1f71190c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28FFD06-3F55-464E-AE79-11D673B66B8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164269A-2B2F-4F64-AA1D-04830BDF2638}">
  <ds:schemaRefs>
    <ds:schemaRef ds:uri="http://schemas.microsoft.com/office/2006/metadata/properties"/>
    <ds:schemaRef ds:uri="http://schemas.microsoft.com/office/infopath/2007/PartnerControls"/>
    <ds:schemaRef ds:uri="7bb26fcd-ba72-4bbf-b389-e35a8816dc95"/>
    <ds:schemaRef ds:uri="9644bfcf-8bdd-41a6-97ac-521b5ea37eb3"/>
  </ds:schemaRefs>
</ds:datastoreItem>
</file>

<file path=customXml/itemProps3.xml><?xml version="1.0" encoding="utf-8"?>
<ds:datastoreItem xmlns:ds="http://schemas.openxmlformats.org/officeDocument/2006/customXml" ds:itemID="{37EDAEC6-2B76-4666-B9E2-E580A2B8F56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bb26fcd-ba72-4bbf-b389-e35a8816dc95"/>
    <ds:schemaRef ds:uri="9644bfcf-8bdd-41a6-97ac-521b5ea37eb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257</Words>
  <Application>Microsoft Macintosh PowerPoint</Application>
  <PresentationFormat>Widescreen</PresentationFormat>
  <Paragraphs>124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　剛暉</dc:creator>
  <cp:lastModifiedBy>B.R.SUDARMA BOGAHAWATHTHA</cp:lastModifiedBy>
  <cp:revision>4</cp:revision>
  <dcterms:created xsi:type="dcterms:W3CDTF">2025-12-15T05:34:25Z</dcterms:created>
  <dcterms:modified xsi:type="dcterms:W3CDTF">2026-02-17T02:30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C8AC90AE570E847BE20D517469CBEDD</vt:lpwstr>
  </property>
</Properties>
</file>